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12"/>
    <p:restoredTop sz="94595"/>
  </p:normalViewPr>
  <p:slideViewPr>
    <p:cSldViewPr snapToGrid="0" snapToObjects="1">
      <p:cViewPr varScale="1">
        <p:scale>
          <a:sx n="102" d="100"/>
          <a:sy n="102" d="100"/>
        </p:scale>
        <p:origin x="6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AA1904-7F81-2D4D-A4D4-539CC5D332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8EF29CB-B5B7-3A46-825B-8AC9BDAB38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23EFCB-1741-FA4A-AB27-7A2331659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C7E91D-AF23-FE49-B47A-4A2DB785F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8C41FD-F08F-3B45-9894-2DA6063D2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990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6EEFE8-A612-DA45-804D-CAE0DD5294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6B8B99D-BD3D-024C-B2BB-346546083F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0628A2-0495-A24E-8932-91B4F0CFA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ED1144-5701-1648-99CD-00A6105D8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44F8ED-C040-B648-BCC9-5D967C08D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7088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2A3D004-56DD-8F4D-8505-1BFA5F324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69805C-CC62-2D42-97A4-303559B440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9809B2-2B9F-EF43-B26D-8C743E70F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8FB478-BBD1-B441-9921-B67BBC27F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C8E26E-5119-8648-AE5C-48484C4FA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038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99A0D6-075E-DC4D-9474-7783C10AEE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AB1382-1750-A045-BF98-938D334762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68980F-9E7E-F148-ACA0-A8209658E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02D75B-F10B-2D4E-90C1-DD818DF2A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D84104-744D-0044-9F80-60873E2F4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199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B6B0C-2C33-5E42-BA6F-398B3E154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23BBE28-83EB-9149-A2AD-6EE2FD3E86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F95BE1-D95A-F249-914A-4A42DD2B2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C2707-C9AB-6041-91EA-58D8C548C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C411EB-EEF9-2B4A-8727-B6A569D0F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4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CC03D3-7391-EE4A-A391-76D40C612A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034FF7-F9C9-8E47-8F1C-B16EEE9D92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3D9A28-8BB9-2548-B95E-67AF7E00BA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834CF8-117D-F448-836E-D58C1E2A8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7A4678C-C546-5342-86F3-9BE9A0514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1B085B-479A-0843-83FD-902D1FE16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5158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0ED8AB-48C4-E34F-AD4F-25FAA0869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FE6DD1-9C11-8249-AAAF-F84739369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FD7A649-463A-6B44-8F8D-1D245F9B3E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A93ED29-4B97-3A44-8DFB-1F25C66120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F6179F6-75AE-3048-B332-7CB95D68A6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E2755DC-F609-7B4E-ACD0-45EAC6EB6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8076DAC-8EC1-E44E-96C8-705CF4029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DEEE2E2-1DB3-1D46-8ECE-C580DF2E2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9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EAE0F8-BC18-3340-A9A1-380C86C66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445747-2D3E-5747-A1F2-ABCF8A8E5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10586D6-6138-F444-A65C-DA33142D4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FB08212-A100-4C4A-B728-60E026F2D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572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309DFD3-D1AF-EA4D-B69D-D825B6A15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376EBC-A537-4146-AB40-D8165AEBA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02EEE88-7DB1-9645-BF63-8C45997A7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815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01FAEC-34A6-4A48-8EBD-8C599AD7E1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F3E00F-9F97-A849-B1F3-4170F4614E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BC4715C-971D-AA4E-8276-53CEF492BB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BA28A6-23CA-714F-B8C3-745CA9201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B30CA8E-2A35-E043-BE98-89EA6D265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6A7896-F84A-EE40-94A0-E329576EF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272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408724-D696-A74D-99FC-D041DE7CE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65759AE-C355-0A47-99A5-7197236649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438199F-9750-D140-BBA6-C3F8BFDBCB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91C150D-88D2-EF45-BA1D-74F57B7A8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BE856B5-CA54-9241-9AE4-062B8E141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DEF631-FA02-584B-A9F8-1212F2748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312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11C4F4D-9BD0-644D-BC11-0856C0371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0A6C76-0518-1448-BC60-BFB369862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58D81D-ABCA-6A41-B68A-CD3592880B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8B1ED-D22E-804D-B956-AB221C5A81E4}" type="datetimeFigureOut">
              <a:rPr kumimoji="1" lang="ja-JP" altLang="en-US" smtClean="0"/>
              <a:t>2021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4E03FA-A0AD-204E-B63C-E1F100A5DC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C96B98-DE98-024A-8538-668AC871CB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9C74C-72E1-E940-A9DD-CF6837392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105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5">
            <a:extLst>
              <a:ext uri="{FF2B5EF4-FFF2-40B4-BE49-F238E27FC236}">
                <a16:creationId xmlns:a16="http://schemas.microsoft.com/office/drawing/2014/main" id="{7C734B23-20BA-274B-BCF4-911080A71A5E}"/>
              </a:ext>
            </a:extLst>
          </p:cNvPr>
          <p:cNvSpPr/>
          <p:nvPr/>
        </p:nvSpPr>
        <p:spPr>
          <a:xfrm>
            <a:off x="2140360" y="4414594"/>
            <a:ext cx="452726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25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5" name="正方形/長方形 5">
            <a:extLst>
              <a:ext uri="{FF2B5EF4-FFF2-40B4-BE49-F238E27FC236}">
                <a16:creationId xmlns:a16="http://schemas.microsoft.com/office/drawing/2014/main" id="{B59C82FD-FBAF-4546-A76C-0AFE20EE514D}"/>
              </a:ext>
            </a:extLst>
          </p:cNvPr>
          <p:cNvSpPr/>
          <p:nvPr/>
        </p:nvSpPr>
        <p:spPr>
          <a:xfrm>
            <a:off x="2140360" y="3824863"/>
            <a:ext cx="452726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37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pic>
        <p:nvPicPr>
          <p:cNvPr id="7" name="Picture 72" descr="A picture containing sitting, photo, front, side&#10;&#10;Description automatically generated">
            <a:extLst>
              <a:ext uri="{FF2B5EF4-FFF2-40B4-BE49-F238E27FC236}">
                <a16:creationId xmlns:a16="http://schemas.microsoft.com/office/drawing/2014/main" id="{D60C21CC-0EE6-8B41-8B10-35165A4774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521" r="29596" b="6257"/>
          <a:stretch/>
        </p:blipFill>
        <p:spPr>
          <a:xfrm>
            <a:off x="828579" y="1849311"/>
            <a:ext cx="1371076" cy="3616548"/>
          </a:xfrm>
          <a:prstGeom prst="rect">
            <a:avLst/>
          </a:prstGeom>
          <a:noFill/>
        </p:spPr>
      </p:pic>
      <p:sp>
        <p:nvSpPr>
          <p:cNvPr id="9" name="正方形/長方形 5">
            <a:extLst>
              <a:ext uri="{FF2B5EF4-FFF2-40B4-BE49-F238E27FC236}">
                <a16:creationId xmlns:a16="http://schemas.microsoft.com/office/drawing/2014/main" id="{3E9689FE-80F5-7E43-9A40-9F317A943221}"/>
              </a:ext>
            </a:extLst>
          </p:cNvPr>
          <p:cNvSpPr/>
          <p:nvPr/>
        </p:nvSpPr>
        <p:spPr>
          <a:xfrm>
            <a:off x="1074639" y="1401789"/>
            <a:ext cx="745266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WT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0" name="正方形/長方形 5">
            <a:extLst>
              <a:ext uri="{FF2B5EF4-FFF2-40B4-BE49-F238E27FC236}">
                <a16:creationId xmlns:a16="http://schemas.microsoft.com/office/drawing/2014/main" id="{7D1800AB-0AE5-1440-9BB8-3F9673672AEA}"/>
              </a:ext>
            </a:extLst>
          </p:cNvPr>
          <p:cNvSpPr/>
          <p:nvPr/>
        </p:nvSpPr>
        <p:spPr>
          <a:xfrm>
            <a:off x="1364426" y="1401789"/>
            <a:ext cx="1228660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ΔGZMB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80EF1CA-0022-DE4F-BDB7-6B4023D8373D}"/>
              </a:ext>
            </a:extLst>
          </p:cNvPr>
          <p:cNvSpPr txBox="1"/>
          <p:nvPr/>
        </p:nvSpPr>
        <p:spPr>
          <a:xfrm>
            <a:off x="1056806" y="90536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GZMB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705068C2-FD53-0640-A8B2-1F9009970C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5489" y="1843295"/>
            <a:ext cx="1207521" cy="3622563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B2B7FAC-DA4A-C14A-97B2-E89659FB882C}"/>
              </a:ext>
            </a:extLst>
          </p:cNvPr>
          <p:cNvSpPr txBox="1"/>
          <p:nvPr/>
        </p:nvSpPr>
        <p:spPr>
          <a:xfrm>
            <a:off x="3346140" y="905363"/>
            <a:ext cx="1150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α</a:t>
            </a:r>
            <a:r>
              <a:rPr lang="en-US" altLang="ja-JP" dirty="0">
                <a:latin typeface="Helvetica" pitchFamily="2" charset="0"/>
                <a:cs typeface="Helvetica"/>
              </a:rPr>
              <a:t>-Tubulin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15" name="Picture 53" descr="A close up of a white wall&#10;&#10;Description automatically generated">
            <a:extLst>
              <a:ext uri="{FF2B5EF4-FFF2-40B4-BE49-F238E27FC236}">
                <a16:creationId xmlns:a16="http://schemas.microsoft.com/office/drawing/2014/main" id="{BBFE6841-1E33-E044-8780-1F4DFF04A5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19" t="11581" r="27013" b="21235"/>
          <a:stretch/>
        </p:blipFill>
        <p:spPr>
          <a:xfrm>
            <a:off x="5853422" y="2212357"/>
            <a:ext cx="2263121" cy="3120769"/>
          </a:xfrm>
          <a:prstGeom prst="rect">
            <a:avLst/>
          </a:prstGeom>
        </p:spPr>
      </p:pic>
      <p:sp>
        <p:nvSpPr>
          <p:cNvPr id="16" name="正方形/長方形 5">
            <a:extLst>
              <a:ext uri="{FF2B5EF4-FFF2-40B4-BE49-F238E27FC236}">
                <a16:creationId xmlns:a16="http://schemas.microsoft.com/office/drawing/2014/main" id="{A56F871D-468B-1A40-B0C3-64076269C92E}"/>
              </a:ext>
            </a:extLst>
          </p:cNvPr>
          <p:cNvSpPr/>
          <p:nvPr/>
        </p:nvSpPr>
        <p:spPr>
          <a:xfrm>
            <a:off x="5638844" y="4289347"/>
            <a:ext cx="452726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25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7" name="正方形/長方形 5">
            <a:extLst>
              <a:ext uri="{FF2B5EF4-FFF2-40B4-BE49-F238E27FC236}">
                <a16:creationId xmlns:a16="http://schemas.microsoft.com/office/drawing/2014/main" id="{4D6B0113-524E-534D-940C-09D09D01B0D8}"/>
              </a:ext>
            </a:extLst>
          </p:cNvPr>
          <p:cNvSpPr/>
          <p:nvPr/>
        </p:nvSpPr>
        <p:spPr>
          <a:xfrm>
            <a:off x="5638844" y="3766866"/>
            <a:ext cx="452726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37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8" name="正方形/長方形 5">
            <a:extLst>
              <a:ext uri="{FF2B5EF4-FFF2-40B4-BE49-F238E27FC236}">
                <a16:creationId xmlns:a16="http://schemas.microsoft.com/office/drawing/2014/main" id="{945B2CBE-1BCC-6F4B-B882-41CAB4091BD3}"/>
              </a:ext>
            </a:extLst>
          </p:cNvPr>
          <p:cNvSpPr/>
          <p:nvPr/>
        </p:nvSpPr>
        <p:spPr>
          <a:xfrm>
            <a:off x="6583573" y="1783458"/>
            <a:ext cx="973908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(-)  IL-15</a:t>
            </a:r>
          </a:p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      +IL-21</a:t>
            </a:r>
            <a:endParaRPr kumimoji="1" lang="ja-JP" altLang="en-US" sz="10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9" name="正方形/長方形 5">
            <a:extLst>
              <a:ext uri="{FF2B5EF4-FFF2-40B4-BE49-F238E27FC236}">
                <a16:creationId xmlns:a16="http://schemas.microsoft.com/office/drawing/2014/main" id="{4461C33C-28B8-F946-9BDB-71DF7F071ECE}"/>
              </a:ext>
            </a:extLst>
          </p:cNvPr>
          <p:cNvSpPr/>
          <p:nvPr/>
        </p:nvSpPr>
        <p:spPr>
          <a:xfrm>
            <a:off x="7178075" y="1788451"/>
            <a:ext cx="973908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(-)  IL-15</a:t>
            </a:r>
          </a:p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      +IL-21</a:t>
            </a:r>
            <a:endParaRPr kumimoji="1" lang="ja-JP" altLang="en-US" sz="10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cxnSp>
        <p:nvCxnSpPr>
          <p:cNvPr id="20" name="Straight Connector 61">
            <a:extLst>
              <a:ext uri="{FF2B5EF4-FFF2-40B4-BE49-F238E27FC236}">
                <a16:creationId xmlns:a16="http://schemas.microsoft.com/office/drawing/2014/main" id="{D170540E-1E4B-6D47-BB25-E2FBECA7085B}"/>
              </a:ext>
            </a:extLst>
          </p:cNvPr>
          <p:cNvCxnSpPr>
            <a:cxnSpLocks/>
          </p:cNvCxnSpPr>
          <p:nvPr/>
        </p:nvCxnSpPr>
        <p:spPr>
          <a:xfrm>
            <a:off x="6687409" y="1800392"/>
            <a:ext cx="48082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62">
            <a:extLst>
              <a:ext uri="{FF2B5EF4-FFF2-40B4-BE49-F238E27FC236}">
                <a16:creationId xmlns:a16="http://schemas.microsoft.com/office/drawing/2014/main" id="{FAFF0D55-B340-FF47-BE29-2ED103707BF4}"/>
              </a:ext>
            </a:extLst>
          </p:cNvPr>
          <p:cNvCxnSpPr>
            <a:cxnSpLocks/>
          </p:cNvCxnSpPr>
          <p:nvPr/>
        </p:nvCxnSpPr>
        <p:spPr>
          <a:xfrm>
            <a:off x="7275920" y="1800392"/>
            <a:ext cx="48082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5">
            <a:extLst>
              <a:ext uri="{FF2B5EF4-FFF2-40B4-BE49-F238E27FC236}">
                <a16:creationId xmlns:a16="http://schemas.microsoft.com/office/drawing/2014/main" id="{E5F93487-87F6-D243-A18C-5C0A0A3DAEE8}"/>
              </a:ext>
            </a:extLst>
          </p:cNvPr>
          <p:cNvSpPr/>
          <p:nvPr/>
        </p:nvSpPr>
        <p:spPr>
          <a:xfrm>
            <a:off x="6737395" y="1381547"/>
            <a:ext cx="745266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WT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23" name="正方形/長方形 5">
            <a:extLst>
              <a:ext uri="{FF2B5EF4-FFF2-40B4-BE49-F238E27FC236}">
                <a16:creationId xmlns:a16="http://schemas.microsoft.com/office/drawing/2014/main" id="{949D8621-F3B8-504A-8CC3-84CB8BFDABC4}"/>
              </a:ext>
            </a:extLst>
          </p:cNvPr>
          <p:cNvSpPr/>
          <p:nvPr/>
        </p:nvSpPr>
        <p:spPr>
          <a:xfrm>
            <a:off x="7157483" y="1381547"/>
            <a:ext cx="1228660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ΔGZMB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082FF894-EF6F-1E4D-B16C-143920A067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92663" y="2212357"/>
            <a:ext cx="2346055" cy="1607482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A158701-9C8E-7D46-B5CF-AD4716836A0B}"/>
              </a:ext>
            </a:extLst>
          </p:cNvPr>
          <p:cNvSpPr txBox="1"/>
          <p:nvPr/>
        </p:nvSpPr>
        <p:spPr>
          <a:xfrm>
            <a:off x="6652010" y="86025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GZM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36DDBF2-148C-E54F-8E6A-2761E49F16B0}"/>
              </a:ext>
            </a:extLst>
          </p:cNvPr>
          <p:cNvSpPr txBox="1"/>
          <p:nvPr/>
        </p:nvSpPr>
        <p:spPr>
          <a:xfrm>
            <a:off x="9593928" y="860256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CD8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12E0F13-8626-8740-82CB-8980534C1189}"/>
              </a:ext>
            </a:extLst>
          </p:cNvPr>
          <p:cNvSpPr txBox="1"/>
          <p:nvPr/>
        </p:nvSpPr>
        <p:spPr>
          <a:xfrm>
            <a:off x="1908321" y="408937"/>
            <a:ext cx="1646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Fig6A, sFig4D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28" name="正方形/長方形 5">
            <a:extLst>
              <a:ext uri="{FF2B5EF4-FFF2-40B4-BE49-F238E27FC236}">
                <a16:creationId xmlns:a16="http://schemas.microsoft.com/office/drawing/2014/main" id="{EF39E787-F19A-8A40-9B69-DF693E34D6EE}"/>
              </a:ext>
            </a:extLst>
          </p:cNvPr>
          <p:cNvSpPr/>
          <p:nvPr/>
        </p:nvSpPr>
        <p:spPr>
          <a:xfrm>
            <a:off x="3356101" y="1401789"/>
            <a:ext cx="745266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WT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29" name="正方形/長方形 5">
            <a:extLst>
              <a:ext uri="{FF2B5EF4-FFF2-40B4-BE49-F238E27FC236}">
                <a16:creationId xmlns:a16="http://schemas.microsoft.com/office/drawing/2014/main" id="{68F51ADF-7030-BF49-9010-921EFC28AAD2}"/>
              </a:ext>
            </a:extLst>
          </p:cNvPr>
          <p:cNvSpPr/>
          <p:nvPr/>
        </p:nvSpPr>
        <p:spPr>
          <a:xfrm>
            <a:off x="3645888" y="1401789"/>
            <a:ext cx="1228660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ΔGZMB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30" name="正方形/長方形 20">
            <a:extLst>
              <a:ext uri="{FF2B5EF4-FFF2-40B4-BE49-F238E27FC236}">
                <a16:creationId xmlns:a16="http://schemas.microsoft.com/office/drawing/2014/main" id="{C016DE19-1E18-934C-A570-03D2AC698B5B}"/>
              </a:ext>
            </a:extLst>
          </p:cNvPr>
          <p:cNvSpPr/>
          <p:nvPr/>
        </p:nvSpPr>
        <p:spPr>
          <a:xfrm>
            <a:off x="4576516" y="3803306"/>
            <a:ext cx="596065" cy="439043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>
                <a:solidFill>
                  <a:schemeClr val="tx1"/>
                </a:solidFill>
                <a:latin typeface="Helvetica"/>
                <a:cs typeface="Helvetica"/>
              </a:rPr>
              <a:t>37</a:t>
            </a:r>
          </a:p>
        </p:txBody>
      </p:sp>
      <p:sp>
        <p:nvSpPr>
          <p:cNvPr id="31" name="正方形/長方形 20">
            <a:extLst>
              <a:ext uri="{FF2B5EF4-FFF2-40B4-BE49-F238E27FC236}">
                <a16:creationId xmlns:a16="http://schemas.microsoft.com/office/drawing/2014/main" id="{7AA28B13-4F4E-4241-A8C0-038F43C47466}"/>
              </a:ext>
            </a:extLst>
          </p:cNvPr>
          <p:cNvSpPr/>
          <p:nvPr/>
        </p:nvSpPr>
        <p:spPr>
          <a:xfrm>
            <a:off x="4576515" y="3308155"/>
            <a:ext cx="596065" cy="591443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>
                <a:solidFill>
                  <a:schemeClr val="tx1"/>
                </a:solidFill>
                <a:latin typeface="Helvetica"/>
                <a:cs typeface="Helvetica"/>
              </a:rPr>
              <a:t>50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253DF11-0ECC-6E4C-989E-A3D1FDAB7A03}"/>
              </a:ext>
            </a:extLst>
          </p:cNvPr>
          <p:cNvSpPr txBox="1"/>
          <p:nvPr/>
        </p:nvSpPr>
        <p:spPr>
          <a:xfrm>
            <a:off x="7915831" y="408937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Fig6B, sFig4E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3" name="正方形/長方形 5">
            <a:extLst>
              <a:ext uri="{FF2B5EF4-FFF2-40B4-BE49-F238E27FC236}">
                <a16:creationId xmlns:a16="http://schemas.microsoft.com/office/drawing/2014/main" id="{00D04F8E-7241-4F40-9239-A6B331031004}"/>
              </a:ext>
            </a:extLst>
          </p:cNvPr>
          <p:cNvSpPr/>
          <p:nvPr/>
        </p:nvSpPr>
        <p:spPr>
          <a:xfrm>
            <a:off x="9397389" y="1750024"/>
            <a:ext cx="973908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(-)  IL-15</a:t>
            </a:r>
          </a:p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      +IL-21</a:t>
            </a:r>
            <a:endParaRPr kumimoji="1" lang="ja-JP" altLang="en-US" sz="10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34" name="正方形/長方形 5">
            <a:extLst>
              <a:ext uri="{FF2B5EF4-FFF2-40B4-BE49-F238E27FC236}">
                <a16:creationId xmlns:a16="http://schemas.microsoft.com/office/drawing/2014/main" id="{279D68B8-B215-9F4A-82E6-20CBE9E3BDC6}"/>
              </a:ext>
            </a:extLst>
          </p:cNvPr>
          <p:cNvSpPr/>
          <p:nvPr/>
        </p:nvSpPr>
        <p:spPr>
          <a:xfrm>
            <a:off x="9991891" y="1755017"/>
            <a:ext cx="973908" cy="440264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(-)  IL-15</a:t>
            </a:r>
          </a:p>
          <a:p>
            <a:r>
              <a:rPr lang="en-US" altLang="ja-JP" sz="10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      +IL-21</a:t>
            </a:r>
            <a:endParaRPr kumimoji="1" lang="ja-JP" altLang="en-US" sz="10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cxnSp>
        <p:nvCxnSpPr>
          <p:cNvPr id="35" name="Straight Connector 61">
            <a:extLst>
              <a:ext uri="{FF2B5EF4-FFF2-40B4-BE49-F238E27FC236}">
                <a16:creationId xmlns:a16="http://schemas.microsoft.com/office/drawing/2014/main" id="{6CF9B890-27BB-BA40-AF04-E669A1A414A1}"/>
              </a:ext>
            </a:extLst>
          </p:cNvPr>
          <p:cNvCxnSpPr>
            <a:cxnSpLocks/>
          </p:cNvCxnSpPr>
          <p:nvPr/>
        </p:nvCxnSpPr>
        <p:spPr>
          <a:xfrm>
            <a:off x="9501225" y="1766958"/>
            <a:ext cx="48082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62">
            <a:extLst>
              <a:ext uri="{FF2B5EF4-FFF2-40B4-BE49-F238E27FC236}">
                <a16:creationId xmlns:a16="http://schemas.microsoft.com/office/drawing/2014/main" id="{9BBDBA84-BADD-0040-A183-3871938E87B0}"/>
              </a:ext>
            </a:extLst>
          </p:cNvPr>
          <p:cNvCxnSpPr>
            <a:cxnSpLocks/>
          </p:cNvCxnSpPr>
          <p:nvPr/>
        </p:nvCxnSpPr>
        <p:spPr>
          <a:xfrm>
            <a:off x="10089736" y="1766958"/>
            <a:ext cx="48082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正方形/長方形 5">
            <a:extLst>
              <a:ext uri="{FF2B5EF4-FFF2-40B4-BE49-F238E27FC236}">
                <a16:creationId xmlns:a16="http://schemas.microsoft.com/office/drawing/2014/main" id="{6594FC7B-C423-374C-A071-CE2AA5EA5E28}"/>
              </a:ext>
            </a:extLst>
          </p:cNvPr>
          <p:cNvSpPr/>
          <p:nvPr/>
        </p:nvSpPr>
        <p:spPr>
          <a:xfrm>
            <a:off x="9551211" y="1348113"/>
            <a:ext cx="745266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WT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38" name="正方形/長方形 5">
            <a:extLst>
              <a:ext uri="{FF2B5EF4-FFF2-40B4-BE49-F238E27FC236}">
                <a16:creationId xmlns:a16="http://schemas.microsoft.com/office/drawing/2014/main" id="{0395875A-93FD-2F46-904D-17AC3CF5AA97}"/>
              </a:ext>
            </a:extLst>
          </p:cNvPr>
          <p:cNvSpPr/>
          <p:nvPr/>
        </p:nvSpPr>
        <p:spPr>
          <a:xfrm>
            <a:off x="9971299" y="1348113"/>
            <a:ext cx="1228660" cy="52986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Helvetica" pitchFamily="2" charset="0"/>
                <a:cs typeface="Helvetica"/>
              </a:rPr>
              <a:t>ΔGZMB</a:t>
            </a:r>
            <a:endParaRPr kumimoji="1" lang="ja-JP" altLang="en-US" sz="1200" dirty="0">
              <a:solidFill>
                <a:schemeClr val="tx1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39" name="正方形/長方形 20">
            <a:extLst>
              <a:ext uri="{FF2B5EF4-FFF2-40B4-BE49-F238E27FC236}">
                <a16:creationId xmlns:a16="http://schemas.microsoft.com/office/drawing/2014/main" id="{CF19A27F-F027-B340-BEB4-849D2E8DA10D}"/>
              </a:ext>
            </a:extLst>
          </p:cNvPr>
          <p:cNvSpPr/>
          <p:nvPr/>
        </p:nvSpPr>
        <p:spPr>
          <a:xfrm>
            <a:off x="8324126" y="3083437"/>
            <a:ext cx="596065" cy="439043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>
                <a:solidFill>
                  <a:schemeClr val="tx1"/>
                </a:solidFill>
                <a:latin typeface="Helvetica"/>
                <a:cs typeface="Helvetica"/>
              </a:rPr>
              <a:t>15</a:t>
            </a:r>
          </a:p>
        </p:txBody>
      </p:sp>
      <p:sp>
        <p:nvSpPr>
          <p:cNvPr id="40" name="正方形/長方形 20">
            <a:extLst>
              <a:ext uri="{FF2B5EF4-FFF2-40B4-BE49-F238E27FC236}">
                <a16:creationId xmlns:a16="http://schemas.microsoft.com/office/drawing/2014/main" id="{4798D94F-52BC-E044-A605-F838D804C6DF}"/>
              </a:ext>
            </a:extLst>
          </p:cNvPr>
          <p:cNvSpPr/>
          <p:nvPr/>
        </p:nvSpPr>
        <p:spPr>
          <a:xfrm>
            <a:off x="8324126" y="2733639"/>
            <a:ext cx="596065" cy="591443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>
                <a:solidFill>
                  <a:schemeClr val="tx1"/>
                </a:solidFill>
                <a:latin typeface="Helvetica"/>
                <a:cs typeface="Helvetica"/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1222942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46</Words>
  <Application>Microsoft Macintosh PowerPoint</Application>
  <PresentationFormat>ワイド画面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榎本　豊</dc:creator>
  <cp:lastModifiedBy>榎本　豊</cp:lastModifiedBy>
  <cp:revision>34</cp:revision>
  <dcterms:created xsi:type="dcterms:W3CDTF">2021-04-15T05:30:22Z</dcterms:created>
  <dcterms:modified xsi:type="dcterms:W3CDTF">2021-04-15T08:02:49Z</dcterms:modified>
</cp:coreProperties>
</file>